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</p:sldIdLst>
  <p:sldSz cx="30603825" cy="14401800"/>
  <p:notesSz cx="6858000" cy="9144000"/>
  <p:defaultTextStyle>
    <a:defPPr>
      <a:defRPr lang="cs-CZ"/>
    </a:defPPr>
    <a:lvl1pPr marL="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1pPr>
    <a:lvl2pPr marL="128587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2pPr>
    <a:lvl3pPr marL="257175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3pPr>
    <a:lvl4pPr marL="385762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4pPr>
    <a:lvl5pPr marL="514350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5pPr>
    <a:lvl6pPr marL="642937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6pPr>
    <a:lvl7pPr marL="771525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7pPr>
    <a:lvl8pPr marL="9001125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8pPr>
    <a:lvl9pPr marL="10287000" algn="l" defTabSz="2571750" rtl="0" eaLnBrk="1" latinLnBrk="0" hangingPunct="1">
      <a:defRPr sz="51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>
        <p:scale>
          <a:sx n="60" d="100"/>
          <a:sy n="60" d="100"/>
        </p:scale>
        <p:origin x="-72" y="-48"/>
      </p:cViewPr>
      <p:guideLst>
        <p:guide orient="horz" pos="4536"/>
        <p:guide pos="96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2295287" y="4473893"/>
            <a:ext cx="26013251" cy="3087053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4590574" y="8161020"/>
            <a:ext cx="21422678" cy="368046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12858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25717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38576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51435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642937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771525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900112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10287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304603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51357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74262097" y="1210153"/>
            <a:ext cx="23043191" cy="25806558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5121890" y="1210153"/>
            <a:ext cx="68630142" cy="25806558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89200755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7016322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2417491" y="9254491"/>
            <a:ext cx="26013251" cy="2860358"/>
          </a:xfrm>
        </p:spPr>
        <p:txBody>
          <a:bodyPr anchor="t"/>
          <a:lstStyle>
            <a:lvl1pPr algn="l">
              <a:defRPr sz="113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2417491" y="6104098"/>
            <a:ext cx="26013251" cy="3150393"/>
          </a:xfrm>
        </p:spPr>
        <p:txBody>
          <a:bodyPr anchor="b"/>
          <a:lstStyle>
            <a:lvl1pPr marL="0" indent="0">
              <a:buNone/>
              <a:defRPr sz="5600">
                <a:solidFill>
                  <a:schemeClr val="tx1">
                    <a:tint val="75000"/>
                  </a:schemeClr>
                </a:solidFill>
              </a:defRPr>
            </a:lvl1pPr>
            <a:lvl2pPr marL="1285875" indent="0">
              <a:buNone/>
              <a:defRPr sz="5100">
                <a:solidFill>
                  <a:schemeClr val="tx1">
                    <a:tint val="75000"/>
                  </a:schemeClr>
                </a:solidFill>
              </a:defRPr>
            </a:lvl2pPr>
            <a:lvl3pPr marL="2571750" indent="0">
              <a:buNone/>
              <a:defRPr sz="4500">
                <a:solidFill>
                  <a:schemeClr val="tx1">
                    <a:tint val="75000"/>
                  </a:schemeClr>
                </a:solidFill>
              </a:defRPr>
            </a:lvl3pPr>
            <a:lvl4pPr marL="3857625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4pPr>
            <a:lvl5pPr marL="514350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5pPr>
            <a:lvl6pPr marL="6429375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6pPr>
            <a:lvl7pPr marL="771525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7pPr>
            <a:lvl8pPr marL="9001125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8pPr>
            <a:lvl9pPr marL="10287000" indent="0">
              <a:buNone/>
              <a:defRPr sz="3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6497146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5121892" y="7057550"/>
            <a:ext cx="45836668" cy="19959160"/>
          </a:xfrm>
        </p:spPr>
        <p:txBody>
          <a:bodyPr/>
          <a:lstStyle>
            <a:lvl1pPr>
              <a:defRPr sz="7900"/>
            </a:lvl1pPr>
            <a:lvl2pPr>
              <a:defRPr sz="6800"/>
            </a:lvl2pPr>
            <a:lvl3pPr>
              <a:defRPr sz="560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51468622" y="7057550"/>
            <a:ext cx="45836665" cy="19959160"/>
          </a:xfrm>
        </p:spPr>
        <p:txBody>
          <a:bodyPr/>
          <a:lstStyle>
            <a:lvl1pPr>
              <a:defRPr sz="7900"/>
            </a:lvl1pPr>
            <a:lvl2pPr>
              <a:defRPr sz="6800"/>
            </a:lvl2pPr>
            <a:lvl3pPr>
              <a:defRPr sz="5600"/>
            </a:lvl3pPr>
            <a:lvl4pPr>
              <a:defRPr sz="5100"/>
            </a:lvl4pPr>
            <a:lvl5pPr>
              <a:defRPr sz="5100"/>
            </a:lvl5pPr>
            <a:lvl6pPr>
              <a:defRPr sz="5100"/>
            </a:lvl6pPr>
            <a:lvl7pPr>
              <a:defRPr sz="5100"/>
            </a:lvl7pPr>
            <a:lvl8pPr>
              <a:defRPr sz="5100"/>
            </a:lvl8pPr>
            <a:lvl9pPr>
              <a:defRPr sz="51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880476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530191" y="576740"/>
            <a:ext cx="27543443" cy="2400300"/>
          </a:xfrm>
        </p:spPr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1530191" y="3223737"/>
            <a:ext cx="13522004" cy="1343500"/>
          </a:xfrm>
        </p:spPr>
        <p:txBody>
          <a:bodyPr anchor="b"/>
          <a:lstStyle>
            <a:lvl1pPr marL="0" indent="0">
              <a:buNone/>
              <a:defRPr sz="6800" b="1"/>
            </a:lvl1pPr>
            <a:lvl2pPr marL="1285875" indent="0">
              <a:buNone/>
              <a:defRPr sz="5600" b="1"/>
            </a:lvl2pPr>
            <a:lvl3pPr marL="2571750" indent="0">
              <a:buNone/>
              <a:defRPr sz="5100" b="1"/>
            </a:lvl3pPr>
            <a:lvl4pPr marL="3857625" indent="0">
              <a:buNone/>
              <a:defRPr sz="4500" b="1"/>
            </a:lvl4pPr>
            <a:lvl5pPr marL="5143500" indent="0">
              <a:buNone/>
              <a:defRPr sz="4500" b="1"/>
            </a:lvl5pPr>
            <a:lvl6pPr marL="6429375" indent="0">
              <a:buNone/>
              <a:defRPr sz="4500" b="1"/>
            </a:lvl6pPr>
            <a:lvl7pPr marL="7715250" indent="0">
              <a:buNone/>
              <a:defRPr sz="4500" b="1"/>
            </a:lvl7pPr>
            <a:lvl8pPr marL="9001125" indent="0">
              <a:buNone/>
              <a:defRPr sz="4500" b="1"/>
            </a:lvl8pPr>
            <a:lvl9pPr marL="10287000" indent="0">
              <a:buNone/>
              <a:defRPr sz="45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1530191" y="4567237"/>
            <a:ext cx="13522004" cy="8297705"/>
          </a:xfrm>
        </p:spPr>
        <p:txBody>
          <a:bodyPr/>
          <a:lstStyle>
            <a:lvl1pPr>
              <a:defRPr sz="6800"/>
            </a:lvl1pPr>
            <a:lvl2pPr>
              <a:defRPr sz="5600"/>
            </a:lvl2pPr>
            <a:lvl3pPr>
              <a:defRPr sz="51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15546320" y="3223737"/>
            <a:ext cx="13527316" cy="1343500"/>
          </a:xfrm>
        </p:spPr>
        <p:txBody>
          <a:bodyPr anchor="b"/>
          <a:lstStyle>
            <a:lvl1pPr marL="0" indent="0">
              <a:buNone/>
              <a:defRPr sz="6800" b="1"/>
            </a:lvl1pPr>
            <a:lvl2pPr marL="1285875" indent="0">
              <a:buNone/>
              <a:defRPr sz="5600" b="1"/>
            </a:lvl2pPr>
            <a:lvl3pPr marL="2571750" indent="0">
              <a:buNone/>
              <a:defRPr sz="5100" b="1"/>
            </a:lvl3pPr>
            <a:lvl4pPr marL="3857625" indent="0">
              <a:buNone/>
              <a:defRPr sz="4500" b="1"/>
            </a:lvl4pPr>
            <a:lvl5pPr marL="5143500" indent="0">
              <a:buNone/>
              <a:defRPr sz="4500" b="1"/>
            </a:lvl5pPr>
            <a:lvl6pPr marL="6429375" indent="0">
              <a:buNone/>
              <a:defRPr sz="4500" b="1"/>
            </a:lvl6pPr>
            <a:lvl7pPr marL="7715250" indent="0">
              <a:buNone/>
              <a:defRPr sz="4500" b="1"/>
            </a:lvl7pPr>
            <a:lvl8pPr marL="9001125" indent="0">
              <a:buNone/>
              <a:defRPr sz="4500" b="1"/>
            </a:lvl8pPr>
            <a:lvl9pPr marL="10287000" indent="0">
              <a:buNone/>
              <a:defRPr sz="45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15546320" y="4567237"/>
            <a:ext cx="13527316" cy="8297705"/>
          </a:xfrm>
        </p:spPr>
        <p:txBody>
          <a:bodyPr/>
          <a:lstStyle>
            <a:lvl1pPr>
              <a:defRPr sz="6800"/>
            </a:lvl1pPr>
            <a:lvl2pPr>
              <a:defRPr sz="5600"/>
            </a:lvl2pPr>
            <a:lvl3pPr>
              <a:defRPr sz="5100"/>
            </a:lvl3pPr>
            <a:lvl4pPr>
              <a:defRPr sz="4500"/>
            </a:lvl4pPr>
            <a:lvl5pPr>
              <a:defRPr sz="4500"/>
            </a:lvl5pPr>
            <a:lvl6pPr>
              <a:defRPr sz="4500"/>
            </a:lvl6pPr>
            <a:lvl7pPr>
              <a:defRPr sz="4500"/>
            </a:lvl7pPr>
            <a:lvl8pPr>
              <a:defRPr sz="4500"/>
            </a:lvl8pPr>
            <a:lvl9pPr>
              <a:defRPr sz="4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7074472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953486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9817901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530193" y="573405"/>
            <a:ext cx="10068448" cy="2440305"/>
          </a:xfrm>
        </p:spPr>
        <p:txBody>
          <a:bodyPr anchor="b"/>
          <a:lstStyle>
            <a:lvl1pPr algn="l">
              <a:defRPr sz="56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11965246" y="573406"/>
            <a:ext cx="17108388" cy="12291537"/>
          </a:xfrm>
        </p:spPr>
        <p:txBody>
          <a:bodyPr/>
          <a:lstStyle>
            <a:lvl1pPr>
              <a:defRPr sz="9000"/>
            </a:lvl1pPr>
            <a:lvl2pPr>
              <a:defRPr sz="7900"/>
            </a:lvl2pPr>
            <a:lvl3pPr>
              <a:defRPr sz="6800"/>
            </a:lvl3pPr>
            <a:lvl4pPr>
              <a:defRPr sz="5600"/>
            </a:lvl4pPr>
            <a:lvl5pPr>
              <a:defRPr sz="5600"/>
            </a:lvl5pPr>
            <a:lvl6pPr>
              <a:defRPr sz="5600"/>
            </a:lvl6pPr>
            <a:lvl7pPr>
              <a:defRPr sz="5600"/>
            </a:lvl7pPr>
            <a:lvl8pPr>
              <a:defRPr sz="5600"/>
            </a:lvl8pPr>
            <a:lvl9pPr>
              <a:defRPr sz="5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530193" y="3013711"/>
            <a:ext cx="10068448" cy="9851232"/>
          </a:xfrm>
        </p:spPr>
        <p:txBody>
          <a:bodyPr/>
          <a:lstStyle>
            <a:lvl1pPr marL="0" indent="0">
              <a:buNone/>
              <a:defRPr sz="3900"/>
            </a:lvl1pPr>
            <a:lvl2pPr marL="1285875" indent="0">
              <a:buNone/>
              <a:defRPr sz="3400"/>
            </a:lvl2pPr>
            <a:lvl3pPr marL="2571750" indent="0">
              <a:buNone/>
              <a:defRPr sz="2800"/>
            </a:lvl3pPr>
            <a:lvl4pPr marL="3857625" indent="0">
              <a:buNone/>
              <a:defRPr sz="2500"/>
            </a:lvl4pPr>
            <a:lvl5pPr marL="5143500" indent="0">
              <a:buNone/>
              <a:defRPr sz="2500"/>
            </a:lvl5pPr>
            <a:lvl6pPr marL="6429375" indent="0">
              <a:buNone/>
              <a:defRPr sz="2500"/>
            </a:lvl6pPr>
            <a:lvl7pPr marL="7715250" indent="0">
              <a:buNone/>
              <a:defRPr sz="2500"/>
            </a:lvl7pPr>
            <a:lvl8pPr marL="9001125" indent="0">
              <a:buNone/>
              <a:defRPr sz="2500"/>
            </a:lvl8pPr>
            <a:lvl9pPr marL="10287000" indent="0">
              <a:buNone/>
              <a:defRPr sz="2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1759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5998564" y="10081260"/>
            <a:ext cx="18362295" cy="1190150"/>
          </a:xfrm>
        </p:spPr>
        <p:txBody>
          <a:bodyPr anchor="b"/>
          <a:lstStyle>
            <a:lvl1pPr algn="l">
              <a:defRPr sz="56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5998564" y="1286828"/>
            <a:ext cx="18362295" cy="8641080"/>
          </a:xfrm>
        </p:spPr>
        <p:txBody>
          <a:bodyPr/>
          <a:lstStyle>
            <a:lvl1pPr marL="0" indent="0">
              <a:buNone/>
              <a:defRPr sz="9000"/>
            </a:lvl1pPr>
            <a:lvl2pPr marL="1285875" indent="0">
              <a:buNone/>
              <a:defRPr sz="7900"/>
            </a:lvl2pPr>
            <a:lvl3pPr marL="2571750" indent="0">
              <a:buNone/>
              <a:defRPr sz="6800"/>
            </a:lvl3pPr>
            <a:lvl4pPr marL="3857625" indent="0">
              <a:buNone/>
              <a:defRPr sz="5600"/>
            </a:lvl4pPr>
            <a:lvl5pPr marL="5143500" indent="0">
              <a:buNone/>
              <a:defRPr sz="5600"/>
            </a:lvl5pPr>
            <a:lvl6pPr marL="6429375" indent="0">
              <a:buNone/>
              <a:defRPr sz="5600"/>
            </a:lvl6pPr>
            <a:lvl7pPr marL="7715250" indent="0">
              <a:buNone/>
              <a:defRPr sz="5600"/>
            </a:lvl7pPr>
            <a:lvl8pPr marL="9001125" indent="0">
              <a:buNone/>
              <a:defRPr sz="5600"/>
            </a:lvl8pPr>
            <a:lvl9pPr marL="10287000" indent="0">
              <a:buNone/>
              <a:defRPr sz="56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5998564" y="11271410"/>
            <a:ext cx="18362295" cy="1690210"/>
          </a:xfrm>
        </p:spPr>
        <p:txBody>
          <a:bodyPr/>
          <a:lstStyle>
            <a:lvl1pPr marL="0" indent="0">
              <a:buNone/>
              <a:defRPr sz="3900"/>
            </a:lvl1pPr>
            <a:lvl2pPr marL="1285875" indent="0">
              <a:buNone/>
              <a:defRPr sz="3400"/>
            </a:lvl2pPr>
            <a:lvl3pPr marL="2571750" indent="0">
              <a:buNone/>
              <a:defRPr sz="2800"/>
            </a:lvl3pPr>
            <a:lvl4pPr marL="3857625" indent="0">
              <a:buNone/>
              <a:defRPr sz="2500"/>
            </a:lvl4pPr>
            <a:lvl5pPr marL="5143500" indent="0">
              <a:buNone/>
              <a:defRPr sz="2500"/>
            </a:lvl5pPr>
            <a:lvl6pPr marL="6429375" indent="0">
              <a:buNone/>
              <a:defRPr sz="2500"/>
            </a:lvl6pPr>
            <a:lvl7pPr marL="7715250" indent="0">
              <a:buNone/>
              <a:defRPr sz="2500"/>
            </a:lvl7pPr>
            <a:lvl8pPr marL="9001125" indent="0">
              <a:buNone/>
              <a:defRPr sz="2500"/>
            </a:lvl8pPr>
            <a:lvl9pPr marL="10287000" indent="0">
              <a:buNone/>
              <a:defRPr sz="25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627670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1530191" y="576740"/>
            <a:ext cx="27543443" cy="2400300"/>
          </a:xfrm>
          <a:prstGeom prst="rect">
            <a:avLst/>
          </a:prstGeom>
        </p:spPr>
        <p:txBody>
          <a:bodyPr vert="horz" lIns="257175" tIns="128588" rIns="257175" bIns="128588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1530191" y="3360421"/>
            <a:ext cx="27543443" cy="9504522"/>
          </a:xfrm>
          <a:prstGeom prst="rect">
            <a:avLst/>
          </a:prstGeom>
        </p:spPr>
        <p:txBody>
          <a:bodyPr vert="horz" lIns="257175" tIns="128588" rIns="257175" bIns="128588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1530191" y="13348336"/>
            <a:ext cx="7140893" cy="766763"/>
          </a:xfrm>
          <a:prstGeom prst="rect">
            <a:avLst/>
          </a:prstGeom>
        </p:spPr>
        <p:txBody>
          <a:bodyPr vert="horz" lIns="257175" tIns="128588" rIns="257175" bIns="128588" rtlCol="0" anchor="ctr"/>
          <a:lstStyle>
            <a:lvl1pPr algn="l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B8027C-770F-44D0-94F1-CAB13E77BBA3}" type="datetimeFigureOut">
              <a:rPr lang="cs-CZ" smtClean="0"/>
              <a:t>14.1.2021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10456307" y="13348336"/>
            <a:ext cx="9691211" cy="766763"/>
          </a:xfrm>
          <a:prstGeom prst="rect">
            <a:avLst/>
          </a:prstGeom>
        </p:spPr>
        <p:txBody>
          <a:bodyPr vert="horz" lIns="257175" tIns="128588" rIns="257175" bIns="128588" rtlCol="0" anchor="ctr"/>
          <a:lstStyle>
            <a:lvl1pPr algn="ctr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21932741" y="13348336"/>
            <a:ext cx="7140893" cy="766763"/>
          </a:xfrm>
          <a:prstGeom prst="rect">
            <a:avLst/>
          </a:prstGeom>
        </p:spPr>
        <p:txBody>
          <a:bodyPr vert="horz" lIns="257175" tIns="128588" rIns="257175" bIns="128588" rtlCol="0" anchor="ctr"/>
          <a:lstStyle>
            <a:lvl1pPr algn="r">
              <a:defRPr sz="3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F28ECF-D6B3-4374-8B50-9329C931BA19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107884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2571750" rtl="0" eaLnBrk="1" latinLnBrk="0" hangingPunct="1">
        <a:spcBef>
          <a:spcPct val="0"/>
        </a:spcBef>
        <a:buNone/>
        <a:defRPr sz="12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964406" indent="-964406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9000" kern="1200">
          <a:solidFill>
            <a:schemeClr val="tx1"/>
          </a:solidFill>
          <a:latin typeface="+mn-lt"/>
          <a:ea typeface="+mn-ea"/>
          <a:cs typeface="+mn-cs"/>
        </a:defRPr>
      </a:lvl1pPr>
      <a:lvl2pPr marL="2089547" indent="-803672" algn="l" defTabSz="2571750" rtl="0" eaLnBrk="1" latinLnBrk="0" hangingPunct="1">
        <a:spcBef>
          <a:spcPct val="20000"/>
        </a:spcBef>
        <a:buFont typeface="Arial" panose="020B0604020202020204" pitchFamily="34" charset="0"/>
        <a:buChar char="–"/>
        <a:defRPr sz="7900" kern="1200">
          <a:solidFill>
            <a:schemeClr val="tx1"/>
          </a:solidFill>
          <a:latin typeface="+mn-lt"/>
          <a:ea typeface="+mn-ea"/>
          <a:cs typeface="+mn-cs"/>
        </a:defRPr>
      </a:lvl2pPr>
      <a:lvl3pPr marL="321468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6800" kern="1200">
          <a:solidFill>
            <a:schemeClr val="tx1"/>
          </a:solidFill>
          <a:latin typeface="+mn-lt"/>
          <a:ea typeface="+mn-ea"/>
          <a:cs typeface="+mn-cs"/>
        </a:defRPr>
      </a:lvl3pPr>
      <a:lvl4pPr marL="4500563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–"/>
        <a:defRPr sz="5600" kern="1200">
          <a:solidFill>
            <a:schemeClr val="tx1"/>
          </a:solidFill>
          <a:latin typeface="+mn-lt"/>
          <a:ea typeface="+mn-ea"/>
          <a:cs typeface="+mn-cs"/>
        </a:defRPr>
      </a:lvl4pPr>
      <a:lvl5pPr marL="578643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»"/>
        <a:defRPr sz="5600" kern="1200">
          <a:solidFill>
            <a:schemeClr val="tx1"/>
          </a:solidFill>
          <a:latin typeface="+mn-lt"/>
          <a:ea typeface="+mn-ea"/>
          <a:cs typeface="+mn-cs"/>
        </a:defRPr>
      </a:lvl5pPr>
      <a:lvl6pPr marL="7072313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6pPr>
      <a:lvl7pPr marL="835818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7pPr>
      <a:lvl8pPr marL="9644063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8pPr>
      <a:lvl9pPr marL="10929938" indent="-642938" algn="l" defTabSz="2571750" rtl="0" eaLnBrk="1" latinLnBrk="0" hangingPunct="1">
        <a:spcBef>
          <a:spcPct val="20000"/>
        </a:spcBef>
        <a:buFont typeface="Arial" panose="020B0604020202020204" pitchFamily="34" charset="0"/>
        <a:buChar char="•"/>
        <a:defRPr sz="5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1pPr>
      <a:lvl2pPr marL="128587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2pPr>
      <a:lvl3pPr marL="257175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3pPr>
      <a:lvl4pPr marL="385762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4pPr>
      <a:lvl5pPr marL="514350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5pPr>
      <a:lvl6pPr marL="642937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6pPr>
      <a:lvl7pPr marL="771525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7pPr>
      <a:lvl8pPr marL="9001125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8pPr>
      <a:lvl9pPr marL="10287000" algn="l" defTabSz="2571750" rtl="0" eaLnBrk="1" latinLnBrk="0" hangingPunct="1">
        <a:defRPr sz="5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TextovéPole 36"/>
          <p:cNvSpPr txBox="1"/>
          <p:nvPr/>
        </p:nvSpPr>
        <p:spPr>
          <a:xfrm>
            <a:off x="185349" y="351194"/>
            <a:ext cx="13315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  <a:endParaRPr lang="cs-CZ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4" name="Obrázek 3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0232" y="1441260"/>
            <a:ext cx="10080000" cy="10080000"/>
          </a:xfrm>
          <a:prstGeom prst="rect">
            <a:avLst/>
          </a:prstGeom>
        </p:spPr>
      </p:pic>
      <p:pic>
        <p:nvPicPr>
          <p:cNvPr id="35" name="Obrázek 3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29821" y="1461795"/>
            <a:ext cx="10080000" cy="10080000"/>
          </a:xfrm>
          <a:prstGeom prst="rect">
            <a:avLst/>
          </a:prstGeom>
        </p:spPr>
      </p:pic>
      <p:pic>
        <p:nvPicPr>
          <p:cNvPr id="38" name="Obrázek 3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312061" y="1439210"/>
            <a:ext cx="10080000" cy="100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0779728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Obrázek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40000" y="2160340"/>
            <a:ext cx="8280000" cy="8280000"/>
          </a:xfrm>
          <a:prstGeom prst="rect">
            <a:avLst/>
          </a:prstGeom>
        </p:spPr>
      </p:pic>
      <p:pic>
        <p:nvPicPr>
          <p:cNvPr id="10" name="Obrázek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760000" y="2160340"/>
            <a:ext cx="8280000" cy="8280000"/>
          </a:xfrm>
          <a:prstGeom prst="rect">
            <a:avLst/>
          </a:prstGeom>
        </p:spPr>
      </p:pic>
      <p:sp>
        <p:nvSpPr>
          <p:cNvPr id="6" name="TextovéPole 5"/>
          <p:cNvSpPr txBox="1"/>
          <p:nvPr/>
        </p:nvSpPr>
        <p:spPr>
          <a:xfrm>
            <a:off x="524506" y="11531744"/>
            <a:ext cx="14761640" cy="25545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sz="3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BRIG comparisons of: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a) </a:t>
            </a:r>
            <a:r>
              <a:rPr lang="en-US" sz="3200" i="1" dirty="0" smtClean="0"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  <a:r>
              <a:rPr lang="en-US" sz="32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OXA-48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-like-positive plasmids, 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p51015_OXA-244, p47733_OXA-181 and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p50595_OXA-181, and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b)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3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a</a:t>
            </a:r>
            <a:r>
              <a:rPr lang="en-US" sz="3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DM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-like-positive plasmids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3200" dirty="0" smtClean="0">
                <a:latin typeface="Arial" panose="020B0604020202020204" pitchFamily="34" charset="0"/>
                <a:cs typeface="Arial" panose="020B0604020202020204" pitchFamily="34" charset="0"/>
              </a:rPr>
              <a:t>p51015_NDM-1, 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p50595_NDM1, p47733_NDM-5 and p52148_NDM-5, characterized from </a:t>
            </a:r>
            <a:r>
              <a:rPr lang="en-US" sz="3200" i="1" dirty="0" err="1">
                <a:latin typeface="Arial" panose="020B0604020202020204" pitchFamily="34" charset="0"/>
                <a:cs typeface="Arial" panose="020B0604020202020204" pitchFamily="34" charset="0"/>
              </a:rPr>
              <a:t>Enterobacterales</a:t>
            </a: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 recovered from Czech hospitals.</a:t>
            </a:r>
            <a:endParaRPr lang="cs-CZ" sz="3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ovéPole 6"/>
          <p:cNvSpPr txBox="1"/>
          <p:nvPr/>
        </p:nvSpPr>
        <p:spPr>
          <a:xfrm>
            <a:off x="185349" y="351194"/>
            <a:ext cx="1331504" cy="76944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4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r>
              <a:rPr lang="en-US" sz="4400" b="1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cs-CZ" sz="4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Obrázek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80000" y="2160340"/>
            <a:ext cx="8280000" cy="8280000"/>
          </a:xfrm>
          <a:prstGeom prst="rect">
            <a:avLst/>
          </a:prstGeom>
        </p:spPr>
      </p:pic>
      <p:pic>
        <p:nvPicPr>
          <p:cNvPr id="12" name="Obráze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8000" y="2161220"/>
            <a:ext cx="8280000" cy="828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086807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9</TotalTime>
  <Words>45</Words>
  <Application>Microsoft Office PowerPoint</Application>
  <PresentationFormat>Vlastní</PresentationFormat>
  <Paragraphs>3</Paragraphs>
  <Slides>2</Slides>
  <Notes>0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2</vt:i4>
      </vt:variant>
    </vt:vector>
  </HeadingPairs>
  <TitlesOfParts>
    <vt:vector size="3" baseType="lpstr">
      <vt:lpstr>Motiv systému Office</vt:lpstr>
      <vt:lpstr>Prezentace aplikace PowerPoint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papagiannitsis</dc:creator>
  <cp:lastModifiedBy>papagiannitsis</cp:lastModifiedBy>
  <cp:revision>12</cp:revision>
  <dcterms:created xsi:type="dcterms:W3CDTF">2020-07-17T12:51:03Z</dcterms:created>
  <dcterms:modified xsi:type="dcterms:W3CDTF">2021-01-14T11:09:55Z</dcterms:modified>
</cp:coreProperties>
</file>